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1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358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255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170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38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755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891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362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68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70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384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965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6602B5-D1C1-42B4-8B61-33EF418E2CBC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4E06D-F593-4721-96F6-6E606A9FB5B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92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103307" y="692696"/>
            <a:ext cx="6522648" cy="3557905"/>
            <a:chOff x="257830" y="-72081"/>
            <a:chExt cx="7728187" cy="4247167"/>
          </a:xfrm>
        </p:grpSpPr>
        <p:grpSp>
          <p:nvGrpSpPr>
            <p:cNvPr id="5" name="Gruppo 4"/>
            <p:cNvGrpSpPr/>
            <p:nvPr/>
          </p:nvGrpSpPr>
          <p:grpSpPr>
            <a:xfrm>
              <a:off x="934719" y="553999"/>
              <a:ext cx="6484102" cy="3621087"/>
              <a:chOff x="934719" y="553999"/>
              <a:chExt cx="6484102" cy="3621087"/>
            </a:xfrm>
          </p:grpSpPr>
          <p:pic>
            <p:nvPicPr>
              <p:cNvPr id="12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34719" y="553999"/>
                <a:ext cx="2921000" cy="36210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3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85095" y="553999"/>
                <a:ext cx="3633726" cy="36098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40" t="3078" r="2159" b="43498"/>
            <a:stretch/>
          </p:blipFill>
          <p:spPr bwMode="auto">
            <a:xfrm>
              <a:off x="7406183" y="564821"/>
              <a:ext cx="579834" cy="11418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CasellaDiTesto 14"/>
            <p:cNvSpPr txBox="1"/>
            <p:nvPr/>
          </p:nvSpPr>
          <p:spPr>
            <a:xfrm>
              <a:off x="3475693" y="-72081"/>
              <a:ext cx="864096" cy="3398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it-IT" sz="11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D99%</a:t>
              </a:r>
              <a:r>
                <a:rPr lang="it-IT" sz="1100" dirty="0">
                  <a:solidFill>
                    <a:srgbClr val="000000"/>
                  </a:solidFill>
                  <a:latin typeface="Calibri"/>
                  <a:ea typeface="Times New Roman"/>
                  <a:cs typeface="Times New Roman"/>
                </a:rPr>
                <a:t>[</a:t>
              </a:r>
              <a:r>
                <a:rPr lang="it-IT" sz="11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%]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8" name="CasellaDiTesto 15"/>
            <p:cNvSpPr txBox="1"/>
            <p:nvPr/>
          </p:nvSpPr>
          <p:spPr>
            <a:xfrm>
              <a:off x="1892548" y="204918"/>
              <a:ext cx="1102022" cy="2769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Neuromas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9" name="CasellaDiTesto 16"/>
            <p:cNvSpPr txBox="1"/>
            <p:nvPr/>
          </p:nvSpPr>
          <p:spPr>
            <a:xfrm>
              <a:off x="5009232" y="193589"/>
              <a:ext cx="1368152" cy="3604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Meningiomas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0" name="CasellaDiTesto 17"/>
            <p:cNvSpPr txBox="1"/>
            <p:nvPr/>
          </p:nvSpPr>
          <p:spPr>
            <a:xfrm>
              <a:off x="257830" y="1147102"/>
              <a:ext cx="697118" cy="55954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it-IT" sz="9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First Scenario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1" name="CasellaDiTesto 18"/>
            <p:cNvSpPr txBox="1"/>
            <p:nvPr/>
          </p:nvSpPr>
          <p:spPr>
            <a:xfrm>
              <a:off x="261485" y="2896630"/>
              <a:ext cx="864097" cy="50524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it-IT" sz="900" dirty="0">
                  <a:effectLst/>
                  <a:latin typeface="Calibri"/>
                  <a:ea typeface="Times New Roman"/>
                </a:rPr>
                <a:t>Second Scenario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</p:grpSp>
      <p:sp>
        <p:nvSpPr>
          <p:cNvPr id="2" name="Rettangolo 1"/>
          <p:cNvSpPr/>
          <p:nvPr/>
        </p:nvSpPr>
        <p:spPr>
          <a:xfrm>
            <a:off x="1615000" y="4263817"/>
            <a:ext cx="552157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/>
              <a:t>Fig. S3.</a:t>
            </a:r>
            <a:r>
              <a:rPr lang="en-GB" sz="1100" dirty="0"/>
              <a:t> Robustness evaluation. Worst case scenario </a:t>
            </a:r>
            <a:r>
              <a:rPr lang="en-GB" sz="1100"/>
              <a:t>for D99% </a:t>
            </a:r>
            <a:r>
              <a:rPr lang="en-GB" sz="1100" dirty="0"/>
              <a:t>of CTV for neuroma (left) and meningioma patients (right), </a:t>
            </a:r>
            <a:r>
              <a:rPr lang="en-GB" sz="1100"/>
              <a:t>shift 0.5 mm </a:t>
            </a:r>
            <a:r>
              <a:rPr lang="en-GB" sz="1100" dirty="0"/>
              <a:t>(top left and top right, respectively) and patient shift 1.0 mm (bottom left and bottom right, respectively)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7009220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0</Words>
  <Application>Microsoft Office PowerPoint</Application>
  <PresentationFormat>Presentazione su schermo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Company>Protonterap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ghetto Roberto</dc:creator>
  <cp:lastModifiedBy>Righetto Roberto</cp:lastModifiedBy>
  <cp:revision>6</cp:revision>
  <dcterms:created xsi:type="dcterms:W3CDTF">2021-04-14T10:09:11Z</dcterms:created>
  <dcterms:modified xsi:type="dcterms:W3CDTF">2021-08-20T16:03:58Z</dcterms:modified>
</cp:coreProperties>
</file>